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959225" cy="8640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DDA8C-AAD2-4588-8A65-C1D5329F15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356400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8360" y="4992480"/>
            <a:ext cx="356400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B0145-BCDD-4F64-92D0-DC2011CE9E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02500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8360" y="499248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025000" y="499248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B6D9A-03F4-4578-9CA7-B23C443207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03280" y="201564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608560" y="201564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8360" y="499248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03280" y="499248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608560" y="4992480"/>
            <a:ext cx="114732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215DF2-C21F-4C76-AF76-911017CF80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8360" y="2015640"/>
            <a:ext cx="3564000" cy="5699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649"/>
              </a:spcBef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7DD29-5908-4C95-AA07-050300F730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356400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28180-1CD0-4EDD-9123-4ABEA393E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73916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025000" y="2015640"/>
            <a:ext cx="173916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C9C00-212D-427B-8ACE-A1F9FA91C9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F8859-A8A1-413E-9605-24F16744D7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8360" y="345960"/>
            <a:ext cx="3564000" cy="66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649"/>
              </a:spcBef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70EF1-28D7-4C6C-8D9E-4F17EB92B6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025000" y="2015640"/>
            <a:ext cx="173916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8360" y="499248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D25EE-6FC5-424D-A777-8D292B8918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73916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02500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025000" y="499248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AD4B4-C481-4415-9D11-6476BF4552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836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025000" y="2015640"/>
            <a:ext cx="173916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8360" y="4992480"/>
            <a:ext cx="3564000" cy="27183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/>
          </a:bodyPr>
          <a:p>
            <a:pPr indent="0" algn="r" rtl="1">
              <a:spcBef>
                <a:spcPts val="649"/>
              </a:spcBef>
              <a:buNone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72BBF-B4D0-4314-B2C0-0287220A28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8360" y="345960"/>
            <a:ext cx="3564000" cy="144000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ctr">
            <a:noAutofit/>
          </a:bodyPr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8360" y="2015640"/>
            <a:ext cx="3564000" cy="569916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rmAutofit fontScale="93000"/>
          </a:bodyPr>
          <a:p>
            <a:pPr marL="255240" indent="-255240" algn="r" rtl="1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553680" indent="-212400" algn="r" rtl="1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851400" indent="-169560" algn="r" rtl="1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3" marL="1192680" indent="-169560" algn="r" rtl="1">
              <a:spcBef>
                <a:spcPts val="649"/>
              </a:spcBef>
              <a:buClr>
                <a:srgbClr val="000000"/>
              </a:buClr>
              <a:buFont typeface="Arial"/>
              <a:buChar char="–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4" marL="1533960" indent="-169560" algn="r" rtl="1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5" marL="1533960" indent="-169560" algn="r" rtl="1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6" marL="1533960" indent="-169560" algn="r" rtl="1">
              <a:spcBef>
                <a:spcPts val="649"/>
              </a:spcBef>
              <a:buClr>
                <a:srgbClr val="000000"/>
              </a:buClr>
              <a:buFont typeface="Arial"/>
              <a:buChar char="»"/>
              <a:tabLst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838600" y="7868880"/>
            <a:ext cx="923760" cy="60012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Autofit/>
          </a:bodyPr>
          <a:lstStyle>
            <a:lvl1pPr indent="0" algn="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352520" y="7868880"/>
            <a:ext cx="1255680" cy="60012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Autofit/>
          </a:bodyPr>
          <a:lstStyle>
            <a:lvl1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98000" y="7868880"/>
            <a:ext cx="924120" cy="600120"/>
          </a:xfrm>
          <a:prstGeom prst="rect">
            <a:avLst/>
          </a:prstGeom>
          <a:noFill/>
          <a:ln w="0">
            <a:noFill/>
          </a:ln>
        </p:spPr>
        <p:txBody>
          <a:bodyPr lIns="73440" rIns="73440" tIns="36720" bIns="36720" anchor="t">
            <a:noAutofit/>
          </a:bodyPr>
          <a:lstStyle>
            <a:lvl1pPr indent="0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  <a:defRPr b="0" lang="en-US" sz="11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fld id="{0DA77465-EAAE-4BCB-B38F-B215A502508D}" type="slidenum">
              <a:rPr b="0" lang="en-US" sz="11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12800" y="5910120"/>
            <a:ext cx="72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IF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3389400"/>
            <a:ext cx="3467160" cy="2554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03280" y="3552840"/>
            <a:ext cx="2922480" cy="2152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03280" y="3552840"/>
            <a:ext cx="2922480" cy="215280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04720" y="3552840"/>
            <a:ext cx="0" cy="2152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82760" y="570060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82760" y="534816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82760" y="498636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82760" y="4633920"/>
            <a:ext cx="2196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82760" y="427212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82760" y="391464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2760" y="3552840"/>
            <a:ext cx="21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03280" y="5700600"/>
            <a:ext cx="29224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504720" y="57006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826920" y="57006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1154160" y="57006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1476360" y="57006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1803240" y="57006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2125800" y="570060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2452680" y="5700600"/>
            <a:ext cx="468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2774880" y="5700600"/>
            <a:ext cx="180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3105000" y="5700600"/>
            <a:ext cx="180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3425760" y="5700600"/>
            <a:ext cx="468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63480" y="4098960"/>
            <a:ext cx="2441520" cy="1606680"/>
          </a:xfrm>
          <a:custGeom>
            <a:avLst/>
            <a:gdLst/>
            <a:ahLst/>
            <a:rect l="l" t="t" r="r" b="b"/>
            <a:pathLst>
              <a:path w="446" h="250">
                <a:moveTo>
                  <a:pt x="0" y="249"/>
                </a:moveTo>
                <a:lnTo>
                  <a:pt x="29" y="214"/>
                </a:lnTo>
                <a:lnTo>
                  <a:pt x="59" y="245"/>
                </a:lnTo>
                <a:lnTo>
                  <a:pt x="89" y="250"/>
                </a:lnTo>
                <a:lnTo>
                  <a:pt x="119" y="244"/>
                </a:lnTo>
                <a:lnTo>
                  <a:pt x="148" y="244"/>
                </a:lnTo>
                <a:lnTo>
                  <a:pt x="178" y="242"/>
                </a:lnTo>
                <a:lnTo>
                  <a:pt x="208" y="227"/>
                </a:lnTo>
                <a:lnTo>
                  <a:pt x="238" y="196"/>
                </a:lnTo>
                <a:lnTo>
                  <a:pt x="267" y="154"/>
                </a:lnTo>
                <a:lnTo>
                  <a:pt x="297" y="0"/>
                </a:lnTo>
                <a:lnTo>
                  <a:pt x="327" y="3"/>
                </a:lnTo>
                <a:lnTo>
                  <a:pt x="356" y="33"/>
                </a:lnTo>
                <a:lnTo>
                  <a:pt x="386" y="86"/>
                </a:lnTo>
                <a:lnTo>
                  <a:pt x="416" y="200"/>
                </a:lnTo>
                <a:lnTo>
                  <a:pt x="446" y="243"/>
                </a:lnTo>
              </a:path>
            </a:pathLst>
          </a:custGeom>
          <a:noFill/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63480" y="3898800"/>
            <a:ext cx="2441520" cy="1806840"/>
          </a:xfrm>
          <a:custGeom>
            <a:avLst/>
            <a:gdLst/>
            <a:ahLst/>
            <a:rect l="l" t="t" r="r" b="b"/>
            <a:pathLst>
              <a:path w="446" h="281">
                <a:moveTo>
                  <a:pt x="0" y="281"/>
                </a:moveTo>
                <a:lnTo>
                  <a:pt x="29" y="277"/>
                </a:lnTo>
                <a:lnTo>
                  <a:pt x="59" y="278"/>
                </a:lnTo>
                <a:lnTo>
                  <a:pt x="89" y="280"/>
                </a:lnTo>
                <a:lnTo>
                  <a:pt x="119" y="280"/>
                </a:lnTo>
                <a:lnTo>
                  <a:pt x="148" y="279"/>
                </a:lnTo>
                <a:lnTo>
                  <a:pt x="178" y="279"/>
                </a:lnTo>
                <a:lnTo>
                  <a:pt x="208" y="268"/>
                </a:lnTo>
                <a:lnTo>
                  <a:pt x="238" y="254"/>
                </a:lnTo>
                <a:lnTo>
                  <a:pt x="267" y="192"/>
                </a:lnTo>
                <a:lnTo>
                  <a:pt x="297" y="80"/>
                </a:lnTo>
                <a:lnTo>
                  <a:pt x="327" y="0"/>
                </a:lnTo>
                <a:lnTo>
                  <a:pt x="356" y="11"/>
                </a:lnTo>
                <a:lnTo>
                  <a:pt x="386" y="94"/>
                </a:lnTo>
                <a:lnTo>
                  <a:pt x="416" y="235"/>
                </a:lnTo>
                <a:lnTo>
                  <a:pt x="446" y="280"/>
                </a:lnTo>
              </a:path>
            </a:pathLst>
          </a:custGeom>
          <a:noFill/>
          <a:ln w="11160">
            <a:solidFill>
              <a:srgbClr val="ff66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63480" y="3772080"/>
            <a:ext cx="2598840" cy="1933560"/>
          </a:xfrm>
          <a:custGeom>
            <a:avLst/>
            <a:gdLst/>
            <a:ahLst/>
            <a:rect l="l" t="t" r="r" b="b"/>
            <a:pathLst>
              <a:path w="475" h="301">
                <a:moveTo>
                  <a:pt x="0" y="291"/>
                </a:moveTo>
                <a:lnTo>
                  <a:pt x="29" y="295"/>
                </a:lnTo>
                <a:lnTo>
                  <a:pt x="59" y="298"/>
                </a:lnTo>
                <a:lnTo>
                  <a:pt x="89" y="301"/>
                </a:lnTo>
                <a:lnTo>
                  <a:pt x="119" y="299"/>
                </a:lnTo>
                <a:lnTo>
                  <a:pt x="148" y="300"/>
                </a:lnTo>
                <a:lnTo>
                  <a:pt x="178" y="299"/>
                </a:lnTo>
                <a:lnTo>
                  <a:pt x="208" y="291"/>
                </a:lnTo>
                <a:lnTo>
                  <a:pt x="238" y="289"/>
                </a:lnTo>
                <a:lnTo>
                  <a:pt x="267" y="268"/>
                </a:lnTo>
                <a:lnTo>
                  <a:pt x="297" y="164"/>
                </a:lnTo>
                <a:lnTo>
                  <a:pt x="327" y="71"/>
                </a:lnTo>
                <a:lnTo>
                  <a:pt x="356" y="9"/>
                </a:lnTo>
                <a:lnTo>
                  <a:pt x="386" y="0"/>
                </a:lnTo>
                <a:lnTo>
                  <a:pt x="416" y="214"/>
                </a:lnTo>
                <a:lnTo>
                  <a:pt x="446" y="288"/>
                </a:lnTo>
                <a:lnTo>
                  <a:pt x="475" y="301"/>
                </a:lnTo>
              </a:path>
            </a:pathLst>
          </a:custGeom>
          <a:noFill/>
          <a:ln w="111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39720" y="5662440"/>
            <a:ext cx="5076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98480" y="5443560"/>
            <a:ext cx="4932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963720" y="5643720"/>
            <a:ext cx="47520" cy="568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127160" y="5667480"/>
            <a:ext cx="49320" cy="568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292400" y="5634000"/>
            <a:ext cx="45720" cy="604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49360" y="5634000"/>
            <a:ext cx="49320" cy="604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612800" y="5624640"/>
            <a:ext cx="49320" cy="568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774800" y="5529240"/>
            <a:ext cx="5076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940040" y="5329080"/>
            <a:ext cx="4752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100240" y="5057640"/>
            <a:ext cx="47520" cy="590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263680" y="4067280"/>
            <a:ext cx="47880" cy="586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428920" y="4087800"/>
            <a:ext cx="4752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584440" y="4280040"/>
            <a:ext cx="50760" cy="5688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747880" y="4619520"/>
            <a:ext cx="4932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913120" y="5356080"/>
            <a:ext cx="4752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078000" y="5629320"/>
            <a:ext cx="46080" cy="57240"/>
          </a:xfrm>
          <a:prstGeom prst="ellipse">
            <a:avLst/>
          </a:prstGeom>
          <a:solidFill>
            <a:srgbClr val="000080"/>
          </a:solidFill>
          <a:ln w="64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39720" y="5667480"/>
            <a:ext cx="50760" cy="5688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798480" y="5648400"/>
            <a:ext cx="493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963720" y="5656320"/>
            <a:ext cx="475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127160" y="5662440"/>
            <a:ext cx="493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292400" y="5662440"/>
            <a:ext cx="457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449360" y="5656320"/>
            <a:ext cx="493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612800" y="5656320"/>
            <a:ext cx="493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774800" y="5591160"/>
            <a:ext cx="5076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940040" y="5500800"/>
            <a:ext cx="47520" cy="5688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100240" y="5100480"/>
            <a:ext cx="47520" cy="6192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263680" y="4383000"/>
            <a:ext cx="4788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428920" y="3868560"/>
            <a:ext cx="475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584440" y="3936960"/>
            <a:ext cx="5076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747880" y="4470480"/>
            <a:ext cx="4932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913120" y="5376960"/>
            <a:ext cx="47520" cy="5688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078000" y="5662440"/>
            <a:ext cx="46080" cy="57240"/>
          </a:xfrm>
          <a:prstGeom prst="ellipse">
            <a:avLst/>
          </a:prstGeom>
          <a:solidFill>
            <a:srgbClr val="ff6600"/>
          </a:solidFill>
          <a:ln w="64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39720" y="5610240"/>
            <a:ext cx="5076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798480" y="5634000"/>
            <a:ext cx="49320" cy="604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963720" y="5656320"/>
            <a:ext cx="4752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127160" y="5667480"/>
            <a:ext cx="49320" cy="568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292400" y="5656320"/>
            <a:ext cx="4572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449360" y="5662440"/>
            <a:ext cx="4932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612800" y="5656320"/>
            <a:ext cx="4932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774800" y="5610240"/>
            <a:ext cx="5076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940040" y="5595840"/>
            <a:ext cx="47520" cy="604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100240" y="5462640"/>
            <a:ext cx="4752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263680" y="4792680"/>
            <a:ext cx="4788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428920" y="4195800"/>
            <a:ext cx="47520" cy="601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584440" y="3798720"/>
            <a:ext cx="5076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747880" y="3738600"/>
            <a:ext cx="49320" cy="601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913120" y="5116680"/>
            <a:ext cx="47520" cy="568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078000" y="5591160"/>
            <a:ext cx="46080" cy="5724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120" bIns="-6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236760" y="5667480"/>
            <a:ext cx="47880" cy="5688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53160" y="55990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53160" y="52387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68560" y="4879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68560" y="45277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68560" y="41655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68560" y="38052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68560" y="34466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61160" y="5719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72072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04796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37340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70028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01960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34792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67192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99736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321360" y="5719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593640" y="3681360"/>
            <a:ext cx="1484280" cy="94932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792000" y="3767040"/>
            <a:ext cx="1306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arch for enzym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54120" y="3795840"/>
            <a:ext cx="101520" cy="90360"/>
          </a:xfrm>
          <a:prstGeom prst="ellipse">
            <a:avLst/>
          </a:pr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7640" bIns="1764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54120" y="4138560"/>
            <a:ext cx="101520" cy="92160"/>
          </a:xfrm>
          <a:prstGeom prst="ellipse">
            <a:avLst/>
          </a:prstGeom>
          <a:solidFill>
            <a:srgbClr val="000066"/>
          </a:solidFill>
          <a:ln w="936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720" bIns="1872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792000" y="4100400"/>
            <a:ext cx="1306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arch for develop*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654120" y="4432320"/>
            <a:ext cx="101520" cy="921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720" bIns="18720" anchor="ctr">
            <a:noAutofit/>
          </a:bodyPr>
          <a:p>
            <a:pPr algn="ctr">
              <a:tabLst>
                <a:tab algn="l" pos="0"/>
                <a:tab algn="l" pos="473040"/>
                <a:tab algn="l" pos="946080"/>
                <a:tab algn="l" pos="1419120"/>
                <a:tab algn="l" pos="1892160"/>
                <a:tab algn="l" pos="2365200"/>
                <a:tab algn="l" pos="2838600"/>
                <a:tab algn="l" pos="3311640"/>
                <a:tab algn="l" pos="3784680"/>
                <a:tab algn="l" pos="4257720"/>
                <a:tab algn="l" pos="4730760"/>
                <a:tab algn="l" pos="5203800"/>
                <a:tab algn="l" pos="5676840"/>
                <a:tab algn="l" pos="6149880"/>
                <a:tab algn="l" pos="6622920"/>
                <a:tab algn="l" pos="7095960"/>
                <a:tab algn="l" pos="7569360"/>
                <a:tab algn="l" pos="8042400"/>
                <a:tab algn="l" pos="8515440"/>
                <a:tab algn="l" pos="8988480"/>
                <a:tab algn="l" pos="94615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792000" y="4403880"/>
            <a:ext cx="117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arch for cance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6200000">
            <a:off x="-950760" y="4083840"/>
            <a:ext cx="225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ercent of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500040" y="371520"/>
            <a:ext cx="2932200" cy="26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500040" y="371520"/>
            <a:ext cx="2932200" cy="26366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500040" y="371520"/>
            <a:ext cx="0" cy="2636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68360" y="3008160"/>
            <a:ext cx="25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68360" y="2684520"/>
            <a:ext cx="252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68360" y="2346480"/>
            <a:ext cx="25200" cy="2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68360" y="2021040"/>
            <a:ext cx="25200" cy="4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68360" y="1692360"/>
            <a:ext cx="252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68360" y="1359000"/>
            <a:ext cx="25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68360" y="1031760"/>
            <a:ext cx="252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68360" y="701640"/>
            <a:ext cx="252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468360" y="371520"/>
            <a:ext cx="25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00040" y="3008160"/>
            <a:ext cx="2932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49356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67140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84312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101916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V="1">
            <a:off x="119232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136224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153360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170496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flipV="1">
            <a:off x="187812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205416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222552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2398680" y="300816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257004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273996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V="1">
            <a:off x="291132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V="1">
            <a:off x="3089160" y="3008160"/>
            <a:ext cx="180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flipV="1">
            <a:off x="326088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V="1">
            <a:off x="3432240" y="3008160"/>
            <a:ext cx="144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87520" y="1371600"/>
            <a:ext cx="2757240" cy="1636560"/>
          </a:xfrm>
          <a:custGeom>
            <a:avLst/>
            <a:gdLst/>
            <a:ahLst/>
            <a:rect l="l" t="t" r="r" b="b"/>
            <a:pathLst>
              <a:path w="594" h="285">
                <a:moveTo>
                  <a:pt x="0" y="284"/>
                </a:moveTo>
                <a:lnTo>
                  <a:pt x="37" y="285"/>
                </a:lnTo>
                <a:lnTo>
                  <a:pt x="74" y="283"/>
                </a:lnTo>
                <a:lnTo>
                  <a:pt x="111" y="284"/>
                </a:lnTo>
                <a:lnTo>
                  <a:pt x="148" y="282"/>
                </a:lnTo>
                <a:lnTo>
                  <a:pt x="185" y="283"/>
                </a:lnTo>
                <a:lnTo>
                  <a:pt x="223" y="282"/>
                </a:lnTo>
                <a:lnTo>
                  <a:pt x="260" y="259"/>
                </a:lnTo>
                <a:lnTo>
                  <a:pt x="297" y="236"/>
                </a:lnTo>
                <a:lnTo>
                  <a:pt x="334" y="175"/>
                </a:lnTo>
                <a:lnTo>
                  <a:pt x="371" y="22"/>
                </a:lnTo>
                <a:lnTo>
                  <a:pt x="409" y="0"/>
                </a:lnTo>
                <a:lnTo>
                  <a:pt x="446" y="41"/>
                </a:lnTo>
                <a:lnTo>
                  <a:pt x="483" y="151"/>
                </a:lnTo>
                <a:lnTo>
                  <a:pt x="520" y="255"/>
                </a:lnTo>
                <a:lnTo>
                  <a:pt x="557" y="282"/>
                </a:lnTo>
                <a:lnTo>
                  <a:pt x="594" y="285"/>
                </a:lnTo>
              </a:path>
            </a:pathLst>
          </a:custGeom>
          <a:noFill/>
          <a:ln w="11160">
            <a:solidFill>
              <a:srgbClr val="9933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932040" y="1501920"/>
            <a:ext cx="2412720" cy="1506240"/>
          </a:xfrm>
          <a:custGeom>
            <a:avLst/>
            <a:gdLst/>
            <a:ahLst/>
            <a:rect l="l" t="t" r="r" b="b"/>
            <a:pathLst>
              <a:path w="520" h="262">
                <a:moveTo>
                  <a:pt x="0" y="259"/>
                </a:moveTo>
                <a:lnTo>
                  <a:pt x="37" y="258"/>
                </a:lnTo>
                <a:lnTo>
                  <a:pt x="74" y="260"/>
                </a:lnTo>
                <a:lnTo>
                  <a:pt x="111" y="260"/>
                </a:lnTo>
                <a:lnTo>
                  <a:pt x="149" y="258"/>
                </a:lnTo>
                <a:lnTo>
                  <a:pt x="186" y="242"/>
                </a:lnTo>
                <a:lnTo>
                  <a:pt x="223" y="203"/>
                </a:lnTo>
                <a:lnTo>
                  <a:pt x="260" y="179"/>
                </a:lnTo>
                <a:lnTo>
                  <a:pt x="297" y="8"/>
                </a:lnTo>
                <a:lnTo>
                  <a:pt x="335" y="0"/>
                </a:lnTo>
                <a:lnTo>
                  <a:pt x="372" y="28"/>
                </a:lnTo>
                <a:lnTo>
                  <a:pt x="409" y="90"/>
                </a:lnTo>
                <a:lnTo>
                  <a:pt x="446" y="211"/>
                </a:lnTo>
                <a:lnTo>
                  <a:pt x="483" y="253"/>
                </a:lnTo>
                <a:lnTo>
                  <a:pt x="520" y="262"/>
                </a:lnTo>
              </a:path>
            </a:pathLst>
          </a:custGeom>
          <a:noFill/>
          <a:ln w="11160">
            <a:solidFill>
              <a:srgbClr val="00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793880" y="704880"/>
            <a:ext cx="1550880" cy="2303280"/>
          </a:xfrm>
          <a:custGeom>
            <a:avLst/>
            <a:gdLst/>
            <a:ahLst/>
            <a:rect l="l" t="t" r="r" b="b"/>
            <a:pathLst>
              <a:path w="334" h="401">
                <a:moveTo>
                  <a:pt x="0" y="385"/>
                </a:moveTo>
                <a:lnTo>
                  <a:pt x="37" y="370"/>
                </a:lnTo>
                <a:lnTo>
                  <a:pt x="74" y="346"/>
                </a:lnTo>
                <a:lnTo>
                  <a:pt x="111" y="212"/>
                </a:lnTo>
                <a:lnTo>
                  <a:pt x="149" y="0"/>
                </a:lnTo>
                <a:lnTo>
                  <a:pt x="186" y="149"/>
                </a:lnTo>
                <a:lnTo>
                  <a:pt x="223" y="228"/>
                </a:lnTo>
                <a:lnTo>
                  <a:pt x="260" y="377"/>
                </a:lnTo>
                <a:lnTo>
                  <a:pt x="297" y="393"/>
                </a:lnTo>
                <a:lnTo>
                  <a:pt x="334" y="401"/>
                </a:lnTo>
              </a:path>
            </a:pathLst>
          </a:custGeom>
          <a:noFill/>
          <a:ln w="11160">
            <a:solidFill>
              <a:srgbClr val="8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1965240" y="1511280"/>
            <a:ext cx="1379520" cy="1478160"/>
          </a:xfrm>
          <a:custGeom>
            <a:avLst/>
            <a:gdLst/>
            <a:ahLst/>
            <a:rect l="l" t="t" r="r" b="b"/>
            <a:pathLst>
              <a:path w="297" h="257">
                <a:moveTo>
                  <a:pt x="0" y="234"/>
                </a:moveTo>
                <a:lnTo>
                  <a:pt x="37" y="212"/>
                </a:lnTo>
                <a:lnTo>
                  <a:pt x="74" y="41"/>
                </a:lnTo>
                <a:lnTo>
                  <a:pt x="112" y="36"/>
                </a:lnTo>
                <a:lnTo>
                  <a:pt x="149" y="0"/>
                </a:lnTo>
                <a:lnTo>
                  <a:pt x="186" y="5"/>
                </a:lnTo>
                <a:lnTo>
                  <a:pt x="223" y="167"/>
                </a:lnTo>
                <a:lnTo>
                  <a:pt x="260" y="252"/>
                </a:lnTo>
                <a:lnTo>
                  <a:pt x="297" y="257"/>
                </a:lnTo>
              </a:path>
            </a:pathLst>
          </a:custGeom>
          <a:noFill/>
          <a:ln w="111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965240" y="612720"/>
            <a:ext cx="1035000" cy="2095560"/>
          </a:xfrm>
          <a:custGeom>
            <a:avLst/>
            <a:gdLst/>
            <a:ahLst/>
            <a:rect l="l" t="t" r="r" b="b"/>
            <a:pathLst>
              <a:path w="223" h="365">
                <a:moveTo>
                  <a:pt x="0" y="365"/>
                </a:moveTo>
                <a:lnTo>
                  <a:pt x="37" y="365"/>
                </a:lnTo>
                <a:lnTo>
                  <a:pt x="74" y="0"/>
                </a:lnTo>
                <a:lnTo>
                  <a:pt x="112" y="261"/>
                </a:lnTo>
                <a:lnTo>
                  <a:pt x="149" y="208"/>
                </a:lnTo>
                <a:lnTo>
                  <a:pt x="186" y="261"/>
                </a:lnTo>
                <a:lnTo>
                  <a:pt x="223" y="313"/>
                </a:lnTo>
              </a:path>
            </a:pathLst>
          </a:custGeom>
          <a:noFill/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600120" y="2955960"/>
            <a:ext cx="41400" cy="5220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736560" y="2979720"/>
            <a:ext cx="414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906480" y="2970360"/>
            <a:ext cx="42840" cy="489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079640" y="2973240"/>
            <a:ext cx="41040" cy="5400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251000" y="2962440"/>
            <a:ext cx="4284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422360" y="2970360"/>
            <a:ext cx="41400" cy="489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600200" y="2962440"/>
            <a:ext cx="396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771560" y="2828880"/>
            <a:ext cx="414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1943280" y="2698920"/>
            <a:ext cx="4104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114640" y="2346480"/>
            <a:ext cx="41040" cy="5400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286000" y="1468440"/>
            <a:ext cx="41400" cy="525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462040" y="1341360"/>
            <a:ext cx="432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633760" y="1577880"/>
            <a:ext cx="4284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805120" y="2209680"/>
            <a:ext cx="42840" cy="5400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978280" y="2806560"/>
            <a:ext cx="41040" cy="525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3149640" y="2962440"/>
            <a:ext cx="414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3321000" y="2979720"/>
            <a:ext cx="41400" cy="50760"/>
          </a:xfrm>
          <a:prstGeom prst="ellipse">
            <a:avLst/>
          </a:prstGeom>
          <a:solidFill>
            <a:srgbClr val="993300"/>
          </a:solidFill>
          <a:ln w="4680">
            <a:solidFill>
              <a:srgbClr val="99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906480" y="2962440"/>
            <a:ext cx="4284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079640" y="2955960"/>
            <a:ext cx="41040" cy="5220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251000" y="2970360"/>
            <a:ext cx="42840" cy="489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1422360" y="2970360"/>
            <a:ext cx="41400" cy="489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600200" y="2955960"/>
            <a:ext cx="39600" cy="5220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1771560" y="2863800"/>
            <a:ext cx="41400" cy="525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1943280" y="2641680"/>
            <a:ext cx="4104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114640" y="2502000"/>
            <a:ext cx="41040" cy="5220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286000" y="1521000"/>
            <a:ext cx="4140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462040" y="1474920"/>
            <a:ext cx="4320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633760" y="1635120"/>
            <a:ext cx="4284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805120" y="1990800"/>
            <a:ext cx="42840" cy="5400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978280" y="2685960"/>
            <a:ext cx="41040" cy="5580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149640" y="2932200"/>
            <a:ext cx="41400" cy="4752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3321000" y="2979720"/>
            <a:ext cx="41400" cy="50760"/>
          </a:xfrm>
          <a:prstGeom prst="ellipse">
            <a:avLst/>
          </a:prstGeom>
          <a:solidFill>
            <a:srgbClr val="00ffff"/>
          </a:solidFill>
          <a:ln w="468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1771560" y="2889360"/>
            <a:ext cx="41400" cy="507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943280" y="2801880"/>
            <a:ext cx="41040" cy="5400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2114640" y="2665440"/>
            <a:ext cx="41040" cy="4932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286000" y="1893960"/>
            <a:ext cx="41400" cy="5544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462040" y="676440"/>
            <a:ext cx="43200" cy="507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633760" y="1531800"/>
            <a:ext cx="42840" cy="507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805120" y="1987560"/>
            <a:ext cx="42840" cy="507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978280" y="2841480"/>
            <a:ext cx="41040" cy="525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149640" y="2933640"/>
            <a:ext cx="41400" cy="5580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321000" y="2979720"/>
            <a:ext cx="41400" cy="50760"/>
          </a:xfrm>
          <a:prstGeom prst="ellipse">
            <a:avLst/>
          </a:prstGeom>
          <a:solidFill>
            <a:srgbClr val="800080"/>
          </a:solidFill>
          <a:ln w="468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906480" y="2979720"/>
            <a:ext cx="42840" cy="5076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943280" y="2822400"/>
            <a:ext cx="41040" cy="5400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114640" y="2698920"/>
            <a:ext cx="41040" cy="5076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286000" y="1716120"/>
            <a:ext cx="41400" cy="5220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2462040" y="1685880"/>
            <a:ext cx="43200" cy="5400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2633760" y="1482840"/>
            <a:ext cx="42840" cy="4896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2805120" y="1511280"/>
            <a:ext cx="42840" cy="4752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2978280" y="2440080"/>
            <a:ext cx="41040" cy="5400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149640" y="2932200"/>
            <a:ext cx="41400" cy="4752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321000" y="2955960"/>
            <a:ext cx="41400" cy="52200"/>
          </a:xfrm>
          <a:prstGeom prst="ellipse">
            <a:avLst/>
          </a:prstGeom>
          <a:solidFill>
            <a:srgbClr val="00ccff"/>
          </a:solidFill>
          <a:ln w="468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1943280" y="2684520"/>
            <a:ext cx="41040" cy="4752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114640" y="2684520"/>
            <a:ext cx="41040" cy="4752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2286000" y="587520"/>
            <a:ext cx="41400" cy="4752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2462040" y="2082960"/>
            <a:ext cx="43200" cy="5220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2633760" y="1778040"/>
            <a:ext cx="42840" cy="5220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805120" y="2082960"/>
            <a:ext cx="42840" cy="5220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978280" y="2382840"/>
            <a:ext cx="41040" cy="52560"/>
          </a:xfrm>
          <a:prstGeom prst="ellipse">
            <a:avLst/>
          </a:prstGeom>
          <a:solidFill>
            <a:srgbClr val="000080"/>
          </a:solidFill>
          <a:ln w="468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45240" y="2921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45240" y="25750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263520" y="22446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63520" y="19162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63520" y="1589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63520" y="12556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263520" y="9302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263520" y="5968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263520" y="2667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628200" y="30891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75384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92520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109656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128376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145548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163152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180288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197460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14596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32992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49372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67444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83824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02400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19536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369960" y="30891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 rtl="1">
              <a:tabLst>
                <a:tab algn="l" pos="0"/>
                <a:tab algn="l" pos="679320"/>
                <a:tab algn="l" pos="1359000"/>
                <a:tab algn="l" pos="2038320"/>
                <a:tab algn="l" pos="2717640"/>
                <a:tab algn="l" pos="3397320"/>
                <a:tab algn="l" pos="4076640"/>
                <a:tab algn="l" pos="4756320"/>
                <a:tab algn="l" pos="5435640"/>
                <a:tab algn="l" pos="6114960"/>
                <a:tab algn="l" pos="6794640"/>
                <a:tab algn="l" pos="7473960"/>
                <a:tab algn="l" pos="8153280"/>
                <a:tab algn="l" pos="8832960"/>
                <a:tab algn="l" pos="9512280"/>
                <a:tab algn="l" pos="10191600"/>
                <a:tab algn="l" pos="108712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rot="16200000">
            <a:off x="-745200" y="1305000"/>
            <a:ext cx="183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ercent of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588960" y="601560"/>
            <a:ext cx="1397160" cy="165276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762120" y="646200"/>
            <a:ext cx="1144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sophage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enocarcinom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762120" y="1392120"/>
            <a:ext cx="86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flamm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763200" y="1636560"/>
            <a:ext cx="721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flamm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762120" y="1884240"/>
            <a:ext cx="939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hizophren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633240" y="677880"/>
            <a:ext cx="93960" cy="90360"/>
          </a:xfrm>
          <a:prstGeom prst="ellipse">
            <a:avLst/>
          </a:prstGeom>
          <a:solidFill>
            <a:srgbClr val="9966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7640" bIns="1764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633240" y="1082520"/>
            <a:ext cx="93960" cy="90720"/>
          </a:xfrm>
          <a:prstGeom prst="ellipse">
            <a:avLst/>
          </a:prstGeom>
          <a:solidFill>
            <a:srgbClr val="66ffff"/>
          </a:solidFill>
          <a:ln w="9360">
            <a:solidFill>
              <a:srgbClr val="66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7280" bIns="1728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762120" y="1055520"/>
            <a:ext cx="1144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sophage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enocarcinom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633240" y="1425600"/>
            <a:ext cx="93960" cy="92160"/>
          </a:xfrm>
          <a:prstGeom prst="ellipse">
            <a:avLst/>
          </a:prstGeom>
          <a:solidFill>
            <a:srgbClr val="9933ff"/>
          </a:solidFill>
          <a:ln w="936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720" bIns="1872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633240" y="1666800"/>
            <a:ext cx="93960" cy="9216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720" bIns="1872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633240" y="1911240"/>
            <a:ext cx="93960" cy="88920"/>
          </a:xfrm>
          <a:prstGeom prst="ellipse">
            <a:avLst/>
          </a:prstGeom>
          <a:solidFill>
            <a:srgbClr val="333399"/>
          </a:solidFill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6200" bIns="162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1544760" y="674640"/>
            <a:ext cx="0" cy="117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544760" y="1425600"/>
            <a:ext cx="0" cy="117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544760" y="1085760"/>
            <a:ext cx="0" cy="11592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1544760" y="1663560"/>
            <a:ext cx="0" cy="11772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-63360" y="0"/>
            <a:ext cx="39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spcBef>
                <a:spcPts val="751"/>
              </a:spcBef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-63360" y="3182760"/>
            <a:ext cx="39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spcBef>
                <a:spcPts val="751"/>
              </a:spcBef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181080" y="6265800"/>
            <a:ext cx="359892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3  - Distribution of GIFtS for gene set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A) From transcriptional profiling experiments. GIFtS distributions were generated for 5 lists of genes (see additional file 7: Table S4) generated from transcriptional profiling experiments (arrows mark up and down regulation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733320"/>
                <a:tab algn="l" pos="1467000"/>
                <a:tab algn="l" pos="2200320"/>
                <a:tab algn="l" pos="2933640"/>
                <a:tab algn="l" pos="3666960"/>
                <a:tab algn="l" pos="4400640"/>
                <a:tab algn="l" pos="5133960"/>
                <a:tab algn="l" pos="5867280"/>
                <a:tab algn="l" pos="6600960"/>
                <a:tab algn="l" pos="7334280"/>
                <a:tab algn="l" pos="8067600"/>
                <a:tab algn="l" pos="8801280"/>
                <a:tab algn="l" pos="9534600"/>
                <a:tab algn="l" pos="1026792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B) From keywords search. GIFtS scores distribution was generated for 3 lists of genes (see additional file 8: Table S5) generated from keywords search in GeneCards for the terms develop*, enzyme* , and cancer*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7T20:37:27Z</dcterms:created>
  <dc:creator>Weizmann Institute of Science</dc:creator>
  <dc:description/>
  <dc:language>en-US</dc:language>
  <cp:lastModifiedBy>Weizmann Institute of Science</cp:lastModifiedBy>
  <dcterms:modified xsi:type="dcterms:W3CDTF">2009-10-18T11:54:22Z</dcterms:modified>
  <cp:revision>13</cp:revision>
  <dc:subject/>
  <dc:title>Slide 1</dc:title>
</cp:coreProperties>
</file>